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8CE3D-1681-46A8-98EC-E256562782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6A1F8-46EF-4A1F-B594-8B59545BFD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17656-E207-4543-A4A8-73F7CD6FBA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3D1D9-F3D8-45C0-916B-9D2EF18875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054C4-F516-4962-BEC9-B92587AF07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D6EDB-AD39-4EE1-8659-4040074A6C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81F09-B578-4963-8D73-A8890F8810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7F813-532A-40CE-B736-1D8355F882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A2D4E-E731-440F-AB74-E37A105D0F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575D4-DA15-4DA3-A591-049D27902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180D9-B7C5-48AD-B3E9-A7999DF8B6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36926-4A22-4D5B-A397-7F8BA5DC0C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A4C125-4750-4E35-A66D-FDC64DD1C27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04960" y="1617840"/>
            <a:ext cx="253044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704960" y="1617840"/>
            <a:ext cx="26272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04960" y="1617840"/>
            <a:ext cx="253044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04960" y="1617840"/>
            <a:ext cx="26272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04960" y="1617840"/>
            <a:ext cx="253044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04960" y="1617840"/>
            <a:ext cx="26272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28600" y="152280"/>
            <a:ext cx="8534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2: ANGPT2 block 2, kernel matrix plots.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e ALI population has a distinct kernel representation regardless of the kernel function applied, reflected by significant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valu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990720" y="1219320"/>
            <a:ext cx="2205000" cy="510516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05320" y="1219320"/>
            <a:ext cx="2438280" cy="510516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248520" y="1219320"/>
            <a:ext cx="2286000" cy="510516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85800" y="838080"/>
            <a:ext cx="80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A) Linear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(B) IBS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          (C) Quadrati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8600" y="19810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L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8600" y="4495680"/>
            <a:ext cx="685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on- AL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63" descr=""/>
          <p:cNvPicPr/>
          <p:nvPr/>
        </p:nvPicPr>
        <p:blipFill>
          <a:blip r:embed="rId1"/>
          <a:stretch/>
        </p:blipFill>
        <p:spPr>
          <a:xfrm>
            <a:off x="1066680" y="1371600"/>
            <a:ext cx="2114640" cy="21146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64" descr=""/>
          <p:cNvPicPr/>
          <p:nvPr/>
        </p:nvPicPr>
        <p:blipFill>
          <a:blip r:embed="rId2"/>
          <a:stretch/>
        </p:blipFill>
        <p:spPr>
          <a:xfrm>
            <a:off x="1066680" y="4191120"/>
            <a:ext cx="2038320" cy="20383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65" descr=""/>
          <p:cNvPicPr/>
          <p:nvPr/>
        </p:nvPicPr>
        <p:blipFill>
          <a:blip r:embed="rId3"/>
          <a:stretch/>
        </p:blipFill>
        <p:spPr>
          <a:xfrm>
            <a:off x="3657600" y="1371600"/>
            <a:ext cx="2114640" cy="21146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66" descr=""/>
          <p:cNvPicPr/>
          <p:nvPr/>
        </p:nvPicPr>
        <p:blipFill>
          <a:blip r:embed="rId4"/>
          <a:stretch/>
        </p:blipFill>
        <p:spPr>
          <a:xfrm>
            <a:off x="3581280" y="4127400"/>
            <a:ext cx="2114640" cy="21146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67" descr=""/>
          <p:cNvPicPr/>
          <p:nvPr/>
        </p:nvPicPr>
        <p:blipFill>
          <a:blip r:embed="rId5"/>
          <a:stretch/>
        </p:blipFill>
        <p:spPr>
          <a:xfrm>
            <a:off x="6324480" y="1371600"/>
            <a:ext cx="2114640" cy="21146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68" descr=""/>
          <p:cNvPicPr/>
          <p:nvPr/>
        </p:nvPicPr>
        <p:blipFill>
          <a:blip r:embed="rId6"/>
          <a:stretch/>
        </p:blipFill>
        <p:spPr>
          <a:xfrm>
            <a:off x="6324480" y="4114800"/>
            <a:ext cx="2114640" cy="211464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1143000" y="365760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= 4.5 x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-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629400" y="365760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= 1.0 x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-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886200" y="365760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= 3.4 x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-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20T16:25:26Z</dcterms:created>
  <dc:creator>meyernua</dc:creator>
  <dc:description/>
  <dc:language>en-US</dc:language>
  <cp:lastModifiedBy>meyernua</cp:lastModifiedBy>
  <dcterms:modified xsi:type="dcterms:W3CDTF">2012-06-20T16:26:14Z</dcterms:modified>
  <cp:revision>1</cp:revision>
  <dc:subject/>
  <dc:title>Slide 1</dc:title>
</cp:coreProperties>
</file>